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7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3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_rels/presentation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70.xml.rels" ContentType="application/vnd.openxmlformats-package.relationships+xml"/>
  <Override PartName="/ppt/slideLayouts/slideLayout56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</p:sldMasterIdLst>
  <p:sldIdLst>
    <p:sldId id="256" r:id="rId9"/>
  </p:sldIdLst>
  <p:sldSz cx="9144000" cy="6858000"/>
  <p:notesSz cx="6807200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" Target="slides/slide1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6393AB-855E-4114-BCD4-988211E8DDD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F3C063-DD82-4536-B74F-2DF96F5004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3C8758-DD1D-4A06-BE2C-311A60EBDF3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C61F17-7D36-42C0-9155-7FA0C41354C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A27E71F-B5AB-410D-BB87-8F979B741A9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CF24D90-6876-4F88-A49A-AC0AB78220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6FF2333-04C5-4357-A99E-A7E2A0D72A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9CD534F-E0F3-4A97-A592-B28344265C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BD6734E-4936-486C-AEE7-B9104C60F6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633C602-5582-4815-B900-DE57781F4A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57E6940-E160-4AA7-8200-30634B2D74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A5C98E-BBCD-4A88-853C-723E162566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7BD13DE-8735-4380-95BD-8D52F626BA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E4F06B9-1116-4BA3-BA0F-9A74C08025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ACC6925-D698-42A8-92B2-E5A2D3E1C1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CA67E69-D9A0-4731-B6F5-2D385C61700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1045732-4236-4B92-A5C3-3C107F197C4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E9AF5AC-2781-46E8-9C3F-E97AF41C24C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F2F0948-8FFD-40C4-BE3D-CABD7A24F9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F949112-00D4-4B70-9EEB-98033EE0D0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BF4C501-914A-471B-A510-739FEE2C90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7FF8F1D-B27B-4AE7-B208-BCED2F49D5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06BB77-7EB6-4118-9413-AF64F94A09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24B8C8E-692B-4B89-A0E0-C9BA45FD43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E5327D8-B2A4-43D3-A350-72C6B3E9F1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58F27BE-AE05-41DF-821C-1847BC6AA7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B1C46CE-E35A-45BB-A3DE-0E65AB9CA8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E3A646E-0C6F-43AF-86C6-39658D621A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67E8990-0E35-4A08-9430-525C2B32C9D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FBE9302-6DEF-4091-ADC6-FE0FF5E5DAE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63996D1-B99D-454E-B5EE-7E45ED18847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97F65A5-FFF7-471D-B969-942EEF6895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305DC9B6-5C47-440F-902B-BB92F1683B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8BC08E-C0EE-4104-915F-D8D46AF1B0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026B8AD-8896-41EA-B777-7337A7F250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27711A39-1463-4A8C-82F3-700EC47A5F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D682CDD-C656-4183-A5F2-C828A27003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0B891701-1EB5-4686-AA14-577B5A4CB1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FC296623-FF46-4B5C-82A3-8A411FCF53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5ED784B-4287-4D97-9982-E724EC0FAA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01C0CB06-E70E-4B51-A709-249ADC9D3D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3247198-63B1-4AA7-83F1-C348C1F9BFF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259272E-1810-41A9-AA60-B029A9D481F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57089C0-5E6A-47AA-805F-FD5925C868E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B142A3-33A7-4A29-B0B8-62FF44D600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CBA2F70E-BE8C-4901-8092-A303695A44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8303AC16-B54C-488E-935B-F441CC2C83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365A60E2-D1B9-4131-AC0C-F02723599D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D5477DD-F587-414F-A27F-4E97FCBBFD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32736A79-28F6-453D-9F28-99E922AF68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E2867892-8117-4427-BB3C-B82D062413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77B6205-72C8-4993-A3DB-26EBF83487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7216C19-446F-4C36-B69E-30532B713C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B81CD14C-A70B-43C3-BC2E-EF40AF61CE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2C504033-4459-47F2-ACEE-D04521794A7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37D193-FA0F-4F19-AB76-A7475FE430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AF9E758B-EB14-42F1-8806-DF6E3D5EC1C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B6820829-2438-4D2B-8285-E063DE5DDF6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940DC5BC-0B28-43E9-A726-D970830B3A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70BA35F4-2D78-4D2F-BC0D-4906472F93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7C43062E-F372-4A8F-B2ED-73CBC5B81D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6BC4143A-EDE8-4BC6-8A90-4DE11542C3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549ED1D3-EC3D-495C-A747-1378216F53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9C935270-142B-4873-B345-23C13E0D6C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07DE081-3D96-40E5-B215-1EB37C18F4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30E67CD0-479B-4511-A418-E157845339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062871-2195-4591-B0C6-80A9F44E4C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EE293302-02CD-42CD-830A-A885C5A772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9077D3E8-2DBF-4846-B937-195F174E96A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E7DF0C9B-2F40-4EF8-B887-FECE0D519D4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16E2AA3C-7CC0-471A-8865-6925E22AE57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339FDF37-C26C-4B5A-B731-BAD4259A2A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B5C5BC1B-4B4D-4C3F-A4C6-2337B307E7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CE1371A4-98DD-4D15-94B7-8667D74BF4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C7463383-E3E6-4EBB-AC38-FBD04560D6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FB99E7F0-C8BB-4B31-A102-BA25F51B93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133E055D-CECE-4F57-86FF-6B5E570170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B5A1F4-EB7B-4303-85B6-9149752F14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D07E80CD-D899-4147-9F73-8DC77A4410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856BDCCB-CEBF-47B7-858D-6B4EDA4055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5B9116FE-F1B3-42F8-BD6C-6E906C312E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A8DA0786-BBE3-4B05-B9BD-BE5929CF90C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31587B16-8261-4B94-B0EF-8D7A7D9F3A1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02467D-D0BD-42D7-B81D-4928D58798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680E29F-F0FC-4044-BC4C-32BCC304D88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0196CCC-4E40-485D-A386-25303B24375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  <a:ea typeface="Osaka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81BD94-4CC1-43F4-81F3-530E8A35248F}" type="slidenum">
              <a:rPr b="0" lang="en-US" sz="1400" spc="-1" strike="noStrike">
                <a:solidFill>
                  <a:srgbClr val="000000"/>
                </a:solidFill>
                <a:latin typeface="Times New Roman"/>
                <a:ea typeface="Osaka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PlaceHolder 3"/>
          <p:cNvSpPr>
            <a:spLocks noGrp="1"/>
          </p:cNvSpPr>
          <p:nvPr>
            <p:ph type="dt" idx="10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PlaceHolder 4"/>
          <p:cNvSpPr>
            <a:spLocks noGrp="1"/>
          </p:cNvSpPr>
          <p:nvPr>
            <p:ph type="ftr" idx="11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5"/>
          <p:cNvSpPr>
            <a:spLocks noGrp="1"/>
          </p:cNvSpPr>
          <p:nvPr>
            <p:ph type="sldNum" idx="12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E539130-17B7-496C-9DA2-A59D6AC053C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PlaceHolder 3"/>
          <p:cNvSpPr>
            <a:spLocks noGrp="1"/>
          </p:cNvSpPr>
          <p:nvPr>
            <p:ph type="dt" idx="13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PlaceHolder 4"/>
          <p:cNvSpPr>
            <a:spLocks noGrp="1"/>
          </p:cNvSpPr>
          <p:nvPr>
            <p:ph type="ftr" idx="14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PlaceHolder 5"/>
          <p:cNvSpPr>
            <a:spLocks noGrp="1"/>
          </p:cNvSpPr>
          <p:nvPr>
            <p:ph type="sldNum" idx="15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D69648-FC68-4218-960D-107414DFF89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PlaceHolder 3"/>
          <p:cNvSpPr>
            <a:spLocks noGrp="1"/>
          </p:cNvSpPr>
          <p:nvPr>
            <p:ph type="dt" idx="16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PlaceHolder 4"/>
          <p:cNvSpPr>
            <a:spLocks noGrp="1"/>
          </p:cNvSpPr>
          <p:nvPr>
            <p:ph type="ftr" idx="17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PlaceHolder 5"/>
          <p:cNvSpPr>
            <a:spLocks noGrp="1"/>
          </p:cNvSpPr>
          <p:nvPr>
            <p:ph type="sldNum" idx="18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Osaka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434FE7A-5142-4B1F-80D1-199C6BB16B46}" type="slidenum">
              <a:rPr b="0" lang="en-US" sz="1400" spc="-1" strike="noStrike">
                <a:solidFill>
                  <a:srgbClr val="000000"/>
                </a:solidFill>
                <a:latin typeface="Arial"/>
                <a:ea typeface="Osaka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PlaceHolder 3"/>
          <p:cNvSpPr>
            <a:spLocks noGrp="1"/>
          </p:cNvSpPr>
          <p:nvPr>
            <p:ph type="dt" idx="19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PlaceHolder 4"/>
          <p:cNvSpPr>
            <a:spLocks noGrp="1"/>
          </p:cNvSpPr>
          <p:nvPr>
            <p:ph type="ftr" idx="20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PlaceHolder 5"/>
          <p:cNvSpPr>
            <a:spLocks noGrp="1"/>
          </p:cNvSpPr>
          <p:nvPr>
            <p:ph type="sldNum" idx="21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A5AA99D-665A-4825-AB76-5607CDA658D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Line 4"/>
          <p:cNvSpPr/>
          <p:nvPr/>
        </p:nvSpPr>
        <p:spPr>
          <a:xfrm>
            <a:off x="298440" y="2641680"/>
            <a:ext cx="85852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Text Box 6"/>
          <p:cNvSpPr/>
          <p:nvPr/>
        </p:nvSpPr>
        <p:spPr>
          <a:xfrm>
            <a:off x="216000" y="2158920"/>
            <a:ext cx="23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ental genotyp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Text Box 8"/>
          <p:cNvSpPr/>
          <p:nvPr/>
        </p:nvSpPr>
        <p:spPr>
          <a:xfrm>
            <a:off x="3962520" y="2247840"/>
            <a:ext cx="1168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Wild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Text Box 9"/>
          <p:cNvSpPr/>
          <p:nvPr/>
        </p:nvSpPr>
        <p:spPr>
          <a:xfrm>
            <a:off x="4876920" y="2222640"/>
            <a:ext cx="1701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eterozygou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Text Box 10"/>
          <p:cNvSpPr/>
          <p:nvPr/>
        </p:nvSpPr>
        <p:spPr>
          <a:xfrm>
            <a:off x="6515280" y="2222640"/>
            <a:ext cx="181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omozygou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Text Box 11"/>
          <p:cNvSpPr/>
          <p:nvPr/>
        </p:nvSpPr>
        <p:spPr>
          <a:xfrm>
            <a:off x="3060720" y="2222640"/>
            <a:ext cx="78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g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93" name="グループ化 42"/>
          <p:cNvGrpSpPr/>
          <p:nvPr/>
        </p:nvGrpSpPr>
        <p:grpSpPr>
          <a:xfrm>
            <a:off x="0" y="4660920"/>
            <a:ext cx="9042480" cy="368280"/>
            <a:chOff x="0" y="4660920"/>
            <a:chExt cx="9042480" cy="368280"/>
          </a:xfrm>
        </p:grpSpPr>
        <p:sp>
          <p:nvSpPr>
            <p:cNvPr id="294" name="Text Box 19"/>
            <p:cNvSpPr/>
            <p:nvPr/>
          </p:nvSpPr>
          <p:spPr>
            <a:xfrm>
              <a:off x="0" y="4660920"/>
              <a:ext cx="1333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R702C+/-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Text Box 20"/>
            <p:cNvSpPr/>
            <p:nvPr/>
          </p:nvSpPr>
          <p:spPr>
            <a:xfrm>
              <a:off x="1454040" y="4660920"/>
              <a:ext cx="1130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C57BL/6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Text Box 21"/>
            <p:cNvSpPr/>
            <p:nvPr/>
          </p:nvSpPr>
          <p:spPr>
            <a:xfrm>
              <a:off x="2901960" y="4660920"/>
              <a:ext cx="825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P2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Text Box 22"/>
            <p:cNvSpPr/>
            <p:nvPr/>
          </p:nvSpPr>
          <p:spPr>
            <a:xfrm>
              <a:off x="5632560" y="4660920"/>
              <a:ext cx="901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70(12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Text Box 23"/>
            <p:cNvSpPr/>
            <p:nvPr/>
          </p:nvSpPr>
          <p:spPr>
            <a:xfrm>
              <a:off x="4025880" y="4660920"/>
              <a:ext cx="1206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514(88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Text Box 24"/>
            <p:cNvSpPr/>
            <p:nvPr/>
          </p:nvSpPr>
          <p:spPr>
            <a:xfrm>
              <a:off x="8293320" y="4660920"/>
              <a:ext cx="749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14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Text Box 34"/>
            <p:cNvSpPr/>
            <p:nvPr/>
          </p:nvSpPr>
          <p:spPr>
            <a:xfrm>
              <a:off x="7226640" y="4660920"/>
              <a:ext cx="711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01" name="グループ化 41"/>
          <p:cNvGrpSpPr/>
          <p:nvPr/>
        </p:nvGrpSpPr>
        <p:grpSpPr>
          <a:xfrm>
            <a:off x="0" y="3873600"/>
            <a:ext cx="8877240" cy="368280"/>
            <a:chOff x="0" y="3873600"/>
            <a:chExt cx="8877240" cy="368280"/>
          </a:xfrm>
        </p:grpSpPr>
        <p:sp>
          <p:nvSpPr>
            <p:cNvPr id="302" name="Text Box 16"/>
            <p:cNvSpPr/>
            <p:nvPr/>
          </p:nvSpPr>
          <p:spPr>
            <a:xfrm>
              <a:off x="2901960" y="3873600"/>
              <a:ext cx="825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P2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Text Box 17"/>
            <p:cNvSpPr/>
            <p:nvPr/>
          </p:nvSpPr>
          <p:spPr>
            <a:xfrm>
              <a:off x="0" y="3873600"/>
              <a:ext cx="1333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R702C+/-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Text Box 18"/>
            <p:cNvSpPr/>
            <p:nvPr/>
          </p:nvSpPr>
          <p:spPr>
            <a:xfrm>
              <a:off x="1352520" y="3873600"/>
              <a:ext cx="1333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R702C+/-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Text Box 31"/>
            <p:cNvSpPr/>
            <p:nvPr/>
          </p:nvSpPr>
          <p:spPr>
            <a:xfrm>
              <a:off x="7226280" y="3873600"/>
              <a:ext cx="711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Text Box 32"/>
            <p:cNvSpPr/>
            <p:nvPr/>
          </p:nvSpPr>
          <p:spPr>
            <a:xfrm>
              <a:off x="5651640" y="3873600"/>
              <a:ext cx="863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2(14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Text Box 33"/>
            <p:cNvSpPr/>
            <p:nvPr/>
          </p:nvSpPr>
          <p:spPr>
            <a:xfrm>
              <a:off x="4159080" y="3873600"/>
              <a:ext cx="939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12(86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Text Box 35"/>
            <p:cNvSpPr/>
            <p:nvPr/>
          </p:nvSpPr>
          <p:spPr>
            <a:xfrm>
              <a:off x="8458200" y="3873600"/>
              <a:ext cx="419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9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09" name="グループ化 44"/>
          <p:cNvGrpSpPr/>
          <p:nvPr/>
        </p:nvGrpSpPr>
        <p:grpSpPr>
          <a:xfrm>
            <a:off x="0" y="2819520"/>
            <a:ext cx="8801280" cy="368280"/>
            <a:chOff x="0" y="2819520"/>
            <a:chExt cx="8801280" cy="368280"/>
          </a:xfrm>
        </p:grpSpPr>
        <p:sp>
          <p:nvSpPr>
            <p:cNvPr id="310" name="Text Box 5"/>
            <p:cNvSpPr/>
            <p:nvPr/>
          </p:nvSpPr>
          <p:spPr>
            <a:xfrm>
              <a:off x="0" y="2819520"/>
              <a:ext cx="1333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R702C+/-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Text Box 7"/>
            <p:cNvSpPr/>
            <p:nvPr/>
          </p:nvSpPr>
          <p:spPr>
            <a:xfrm>
              <a:off x="1352520" y="2819520"/>
              <a:ext cx="1333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R702C+/-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Text Box 12"/>
            <p:cNvSpPr/>
            <p:nvPr/>
          </p:nvSpPr>
          <p:spPr>
            <a:xfrm>
              <a:off x="2838600" y="2819520"/>
              <a:ext cx="952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E12.5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Text Box 25"/>
            <p:cNvSpPr/>
            <p:nvPr/>
          </p:nvSpPr>
          <p:spPr>
            <a:xfrm>
              <a:off x="7112160" y="2819520"/>
              <a:ext cx="939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1(25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Text Box 26"/>
            <p:cNvSpPr/>
            <p:nvPr/>
          </p:nvSpPr>
          <p:spPr>
            <a:xfrm>
              <a:off x="4159440" y="2819520"/>
              <a:ext cx="939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1 (25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Text Box 27"/>
            <p:cNvSpPr/>
            <p:nvPr/>
          </p:nvSpPr>
          <p:spPr>
            <a:xfrm>
              <a:off x="5658120" y="2819520"/>
              <a:ext cx="850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2(50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Text Box 36"/>
            <p:cNvSpPr/>
            <p:nvPr/>
          </p:nvSpPr>
          <p:spPr>
            <a:xfrm>
              <a:off x="8534880" y="2819520"/>
              <a:ext cx="266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17" name="グループ化 43"/>
          <p:cNvGrpSpPr/>
          <p:nvPr/>
        </p:nvGrpSpPr>
        <p:grpSpPr>
          <a:xfrm>
            <a:off x="0" y="3346560"/>
            <a:ext cx="9023400" cy="368280"/>
            <a:chOff x="0" y="3346560"/>
            <a:chExt cx="9023400" cy="368280"/>
          </a:xfrm>
        </p:grpSpPr>
        <p:sp>
          <p:nvSpPr>
            <p:cNvPr id="318" name="Text Box 13"/>
            <p:cNvSpPr/>
            <p:nvPr/>
          </p:nvSpPr>
          <p:spPr>
            <a:xfrm>
              <a:off x="2838240" y="3346560"/>
              <a:ext cx="952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E18.5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Text Box 14"/>
            <p:cNvSpPr/>
            <p:nvPr/>
          </p:nvSpPr>
          <p:spPr>
            <a:xfrm>
              <a:off x="0" y="3346560"/>
              <a:ext cx="1333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R702C+/-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Text Box 15"/>
            <p:cNvSpPr/>
            <p:nvPr/>
          </p:nvSpPr>
          <p:spPr>
            <a:xfrm>
              <a:off x="1352520" y="3346560"/>
              <a:ext cx="1333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R702C+/-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Text Box 28"/>
            <p:cNvSpPr/>
            <p:nvPr/>
          </p:nvSpPr>
          <p:spPr>
            <a:xfrm>
              <a:off x="7226280" y="3346560"/>
              <a:ext cx="711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Text Box 29"/>
            <p:cNvSpPr/>
            <p:nvPr/>
          </p:nvSpPr>
          <p:spPr>
            <a:xfrm>
              <a:off x="5632560" y="3346560"/>
              <a:ext cx="901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8(62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Text Box 30"/>
            <p:cNvSpPr/>
            <p:nvPr/>
          </p:nvSpPr>
          <p:spPr>
            <a:xfrm>
              <a:off x="4172040" y="3346560"/>
              <a:ext cx="914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5(38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Text Box 37"/>
            <p:cNvSpPr/>
            <p:nvPr/>
          </p:nvSpPr>
          <p:spPr>
            <a:xfrm>
              <a:off x="8312400" y="3346560"/>
              <a:ext cx="711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25" name="Text Box 38"/>
          <p:cNvSpPr/>
          <p:nvPr/>
        </p:nvSpPr>
        <p:spPr>
          <a:xfrm>
            <a:off x="8064360" y="1968480"/>
            <a:ext cx="10796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ating nu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Text Box 41"/>
          <p:cNvSpPr/>
          <p:nvPr/>
        </p:nvSpPr>
        <p:spPr>
          <a:xfrm>
            <a:off x="4165560" y="1752480"/>
            <a:ext cx="332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umber in each genotyp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テキスト ボックス 1"/>
          <p:cNvSpPr/>
          <p:nvPr/>
        </p:nvSpPr>
        <p:spPr>
          <a:xfrm>
            <a:off x="7226280" y="1765440"/>
            <a:ext cx="67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%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直線コネクタ 2"/>
          <p:cNvSpPr/>
          <p:nvPr/>
        </p:nvSpPr>
        <p:spPr>
          <a:xfrm>
            <a:off x="4381560" y="2222640"/>
            <a:ext cx="36702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Line 4"/>
          <p:cNvSpPr/>
          <p:nvPr/>
        </p:nvSpPr>
        <p:spPr>
          <a:xfrm>
            <a:off x="298440" y="5270400"/>
            <a:ext cx="85852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28T09:37:26Z</dcterms:created>
  <dc:creator>鈴木伸明</dc:creator>
  <dc:description/>
  <dc:language>en-US</dc:language>
  <cp:lastModifiedBy>鈴木伸明</cp:lastModifiedBy>
  <dcterms:modified xsi:type="dcterms:W3CDTF">2013-07-12T11:19:49Z</dcterms:modified>
  <cp:revision>214</cp:revision>
  <dc:subject/>
  <dc:title>PowerPoint プレゼンテーション</dc:title>
</cp:coreProperties>
</file>